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0" r:id="rId4"/>
    <p:sldId id="257" r:id="rId5"/>
    <p:sldId id="258" r:id="rId6"/>
    <p:sldId id="259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이 영석" initials="이영" lastIdx="1" clrIdx="0">
    <p:extLst>
      <p:ext uri="{19B8F6BF-5375-455C-9EA6-DF929625EA0E}">
        <p15:presenceInfo xmlns:p15="http://schemas.microsoft.com/office/powerpoint/2012/main" userId="e199b7d26d9dd6f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76" y="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805125145632712E-2"/>
          <c:y val="7.1367075623981049E-2"/>
          <c:w val="0.88598567780885862"/>
          <c:h val="0.8274983274066652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Sheet1!$A$1:$D$1</c:f>
              <c:numCache>
                <c:formatCode>General</c:formatCode>
                <c:ptCount val="4"/>
                <c:pt idx="0">
                  <c:v>60.4</c:v>
                </c:pt>
                <c:pt idx="1">
                  <c:v>87.9</c:v>
                </c:pt>
                <c:pt idx="2">
                  <c:v>98.4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7B-4A18-B624-BDAF019E5A8D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77552815"/>
        <c:axId val="307467631"/>
      </c:barChart>
      <c:catAx>
        <c:axId val="377552815"/>
        <c:scaling>
          <c:orientation val="minMax"/>
        </c:scaling>
        <c:delete val="0"/>
        <c:axPos val="b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07467631"/>
        <c:crosses val="autoZero"/>
        <c:auto val="1"/>
        <c:lblAlgn val="ctr"/>
        <c:lblOffset val="100"/>
        <c:noMultiLvlLbl val="0"/>
      </c:catAx>
      <c:valAx>
        <c:axId val="307467631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77552815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 i="0" baseline="0">
          <a:solidFill>
            <a:schemeClr val="tx1"/>
          </a:solidFill>
          <a:latin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805125145632712E-2"/>
          <c:y val="6.7046821024431116E-2"/>
          <c:w val="0.88598567780885862"/>
          <c:h val="0.8318187292915010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Sheet1!$A$1:$D$1</c:f>
              <c:numCache>
                <c:formatCode>General</c:formatCode>
                <c:ptCount val="4"/>
                <c:pt idx="0">
                  <c:v>66.7</c:v>
                </c:pt>
                <c:pt idx="1">
                  <c:v>85.9</c:v>
                </c:pt>
                <c:pt idx="2">
                  <c:v>100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4F-451C-A89B-07C5AAF9B4E7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77552815"/>
        <c:axId val="307467631"/>
      </c:barChart>
      <c:catAx>
        <c:axId val="377552815"/>
        <c:scaling>
          <c:orientation val="minMax"/>
        </c:scaling>
        <c:delete val="0"/>
        <c:axPos val="b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07467631"/>
        <c:crosses val="autoZero"/>
        <c:auto val="1"/>
        <c:lblAlgn val="ctr"/>
        <c:lblOffset val="100"/>
        <c:noMultiLvlLbl val="0"/>
      </c:catAx>
      <c:valAx>
        <c:axId val="307467631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77552815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 i="0" baseline="0">
          <a:solidFill>
            <a:schemeClr val="tx1"/>
          </a:solidFill>
          <a:latin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616467232934466E-2"/>
          <c:y val="7.0400389410963396E-2"/>
          <c:w val="0.88598567780885862"/>
          <c:h val="0.8497354014042908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val>
            <c:numRef>
              <c:f>Sheet1!$A$1:$D$1</c:f>
              <c:numCache>
                <c:formatCode>General</c:formatCode>
                <c:ptCount val="4"/>
                <c:pt idx="0">
                  <c:v>68.099999999999994</c:v>
                </c:pt>
                <c:pt idx="1">
                  <c:v>91.9</c:v>
                </c:pt>
                <c:pt idx="2">
                  <c:v>100</c:v>
                </c:pt>
                <c:pt idx="3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84-425D-88FC-08F08A97691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377552815"/>
        <c:axId val="307467631"/>
      </c:barChart>
      <c:catAx>
        <c:axId val="377552815"/>
        <c:scaling>
          <c:orientation val="minMax"/>
        </c:scaling>
        <c:delete val="0"/>
        <c:axPos val="b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07467631"/>
        <c:crosses val="autoZero"/>
        <c:auto val="1"/>
        <c:lblAlgn val="ctr"/>
        <c:lblOffset val="100"/>
        <c:noMultiLvlLbl val="0"/>
      </c:catAx>
      <c:valAx>
        <c:axId val="307467631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ko-KR"/>
          </a:p>
        </c:txPr>
        <c:crossAx val="377552815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 b="1" i="0" baseline="0">
          <a:solidFill>
            <a:schemeClr val="tx1"/>
          </a:solidFill>
          <a:latin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3A8EDB-0D35-452C-A69D-6506F4D305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14D50506-1532-4958-BC6A-434205316F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AB628D8-85C0-4F4C-9980-82CE79EA6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6602546-C2AD-4659-92F4-4F870F3B8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4F09301-6DBB-4F19-8201-EA1B437904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064430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855C5CF-457A-408C-B114-9423E722F1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03FE8C4-FAAF-4ACE-A1CD-C24ADBB242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9B742F1-7BA1-4A4B-847E-AC3E905CF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2AA59F2-BFBD-4CDA-8A4C-89A182F0A5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34572D0-188B-44C3-B0D0-C47563020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374915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0BA47813-F553-46A5-9E69-1986A00648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9DD5726C-E109-4C31-9419-02734B9FC3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7B44238-C14D-4C11-8AAD-9D2FA5D26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C38E4C3-17B3-4DD7-9A62-FFF02C867B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C4939F-A608-4140-A9E3-17291D16A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08887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7A9D070-9116-49F3-B92C-A06D2A5A6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5087D10-76ED-41C3-AD67-7CEE996CB4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8A23F4F-8B30-4CD5-ABA0-C53DAA71D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8DB90D-53F4-4D1B-B7F2-20122C4B7B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B494FBE-66FA-446D-80E0-5B75E5114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80694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44D8A2A-ECBC-4630-8BDF-41742806DE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F932CC5-2D1E-45D9-BBD5-9D1C56765A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AD962FE-33C7-428A-9BD8-1B032A9234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81E9920-026B-4893-BF88-90376A73B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46E0077-8CC5-45A6-851E-2863127CD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50773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433818-9C1E-48EA-8E76-241B5EFF7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A4244F6-BFA1-4739-A9CB-9868E1FDF5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7F2EBF7-5B48-4C45-BEC6-417ADF1432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C7E3A05-53B9-48CA-9260-C8362D39DE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DE58D2A-FE88-4E69-862E-9386D1086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5182A58-3902-4E75-99E0-4538C3E7A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127662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3D950E0-4CBC-4F59-BAA3-1F9EAD70A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5A1C014-B5F0-454E-A374-A8364A7987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AF5705E-5066-4410-AA1E-BEC8203CF8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3601397-479D-4D08-B0BB-B01EF4D722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9E51C10-0976-41E6-97C6-3E8A3E5CB3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A0121E1-3796-4991-8726-A412D75E3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F554534-948F-4434-9658-D647A1CD2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1EA418E-AD98-49C8-AC57-15011FCAD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76338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0E5CFC1-2F36-4AE0-BFDE-2E6FFFB2DF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1FDCECD-2896-4076-B2C7-19DF8DD793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B6923EE0-F471-44E4-AA18-30E81B1D0C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05B27625-BEE4-4E30-8FA0-F63D7AD28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77630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9B6BEA8-6627-48EB-A317-EDFE820B1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7E3CFD3-B444-4B7A-ABC4-FA98FE08F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FCABA587-4531-422A-BDE6-F1C201F14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1648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650CB0C-9F1D-4857-AE94-4841AD76D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74A2B04-F640-4B85-A50F-F351C3DB9C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A409A4A-D6D9-4478-A1A3-3498A52C3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53AE31C-D2AF-4142-9D3D-C03D5F3D3A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90FFF93-2617-4337-B435-65F6EC027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C5CBFB5-A0DB-4880-9C15-E8483B718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107394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57FD47-4CD0-4676-BE28-D2731C54F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E4107BE-AA87-489B-86B8-BFEC157E7E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150E68B-F611-4205-939E-2055A7147A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7F85A35-7401-40A5-800A-09D4E91A6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CCA415E-EAE3-4A71-B757-494857DBD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C4DEF07-0CAC-4FD8-8868-B04E5956F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61379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4F1145C6-53C0-4731-843F-5828670DD8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D47A5EC-E480-4849-8352-CD6B2B2D58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6786AD0-30E9-4A9C-A95B-ADC315D84D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6C9C5-81CA-4401-AA9F-4662E468218E}" type="datetimeFigureOut">
              <a:rPr lang="ko-KR" altLang="en-US" smtClean="0"/>
              <a:t>2021-08-07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928513E-E9BB-423B-96D5-C89F4F3031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66F70E3-38E2-4536-A92A-469EAA04CC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7FC3EB-ADAF-4923-A560-D55983F7118E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956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5">
            <a:extLst>
              <a:ext uri="{FF2B5EF4-FFF2-40B4-BE49-F238E27FC236}">
                <a16:creationId xmlns:a16="http://schemas.microsoft.com/office/drawing/2014/main" id="{82913A8A-F9E7-48C5-AD4B-CE1B89BB70A4}"/>
              </a:ext>
            </a:extLst>
          </p:cNvPr>
          <p:cNvGrpSpPr/>
          <p:nvPr/>
        </p:nvGrpSpPr>
        <p:grpSpPr>
          <a:xfrm>
            <a:off x="1796917" y="273724"/>
            <a:ext cx="8628925" cy="654341"/>
            <a:chOff x="3512191" y="629174"/>
            <a:chExt cx="5167618" cy="654341"/>
          </a:xfrm>
        </p:grpSpPr>
        <p:sp>
          <p:nvSpPr>
            <p:cNvPr id="4" name="직사각형 3">
              <a:extLst>
                <a:ext uri="{FF2B5EF4-FFF2-40B4-BE49-F238E27FC236}">
                  <a16:creationId xmlns:a16="http://schemas.microsoft.com/office/drawing/2014/main" id="{8DC4F017-C9A7-4999-8A4E-EBB86FC6A488}"/>
                </a:ext>
              </a:extLst>
            </p:cNvPr>
            <p:cNvSpPr/>
            <p:nvPr/>
          </p:nvSpPr>
          <p:spPr>
            <a:xfrm>
              <a:off x="3512191" y="629174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8B896AF-1237-4CE9-B7AE-A35F202C8381}"/>
                </a:ext>
              </a:extLst>
            </p:cNvPr>
            <p:cNvSpPr txBox="1"/>
            <p:nvPr/>
          </p:nvSpPr>
          <p:spPr>
            <a:xfrm>
              <a:off x="3909270" y="738231"/>
              <a:ext cx="4404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880 patients receiving mechanical ventilation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그룹 7">
            <a:extLst>
              <a:ext uri="{FF2B5EF4-FFF2-40B4-BE49-F238E27FC236}">
                <a16:creationId xmlns:a16="http://schemas.microsoft.com/office/drawing/2014/main" id="{8F7DEDF7-FEC7-4013-BD98-F7B4C5173828}"/>
              </a:ext>
            </a:extLst>
          </p:cNvPr>
          <p:cNvGrpSpPr/>
          <p:nvPr/>
        </p:nvGrpSpPr>
        <p:grpSpPr>
          <a:xfrm>
            <a:off x="1796918" y="4250092"/>
            <a:ext cx="8628925" cy="654341"/>
            <a:chOff x="3512191" y="629174"/>
            <a:chExt cx="5167618" cy="654341"/>
          </a:xfrm>
        </p:grpSpPr>
        <p:sp>
          <p:nvSpPr>
            <p:cNvPr id="9" name="직사각형 8">
              <a:extLst>
                <a:ext uri="{FF2B5EF4-FFF2-40B4-BE49-F238E27FC236}">
                  <a16:creationId xmlns:a16="http://schemas.microsoft.com/office/drawing/2014/main" id="{6243AFF8-1615-43B4-A36D-2551DD85F479}"/>
                </a:ext>
              </a:extLst>
            </p:cNvPr>
            <p:cNvSpPr/>
            <p:nvPr/>
          </p:nvSpPr>
          <p:spPr>
            <a:xfrm>
              <a:off x="3512191" y="629174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1A11BA1-0EB2-4A7E-8530-7865CAD3F2B7}"/>
                </a:ext>
              </a:extLst>
            </p:cNvPr>
            <p:cNvSpPr txBox="1"/>
            <p:nvPr/>
          </p:nvSpPr>
          <p:spPr>
            <a:xfrm>
              <a:off x="3909270" y="738231"/>
              <a:ext cx="4404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276 patients enrolled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" name="그룹 10">
            <a:extLst>
              <a:ext uri="{FF2B5EF4-FFF2-40B4-BE49-F238E27FC236}">
                <a16:creationId xmlns:a16="http://schemas.microsoft.com/office/drawing/2014/main" id="{EFD79D4F-FDA8-4450-A4D5-78677B322D89}"/>
              </a:ext>
            </a:extLst>
          </p:cNvPr>
          <p:cNvGrpSpPr/>
          <p:nvPr/>
        </p:nvGrpSpPr>
        <p:grpSpPr>
          <a:xfrm>
            <a:off x="405466" y="6045723"/>
            <a:ext cx="5167618" cy="654341"/>
            <a:chOff x="3512191" y="629174"/>
            <a:chExt cx="5167618" cy="654341"/>
          </a:xfrm>
        </p:grpSpPr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63BCF86D-6AB0-4000-808C-0C9A12993AB9}"/>
                </a:ext>
              </a:extLst>
            </p:cNvPr>
            <p:cNvSpPr/>
            <p:nvPr/>
          </p:nvSpPr>
          <p:spPr>
            <a:xfrm>
              <a:off x="3512191" y="629174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B23C9B98-96FC-4F4C-B4A3-C9F15E644454}"/>
                </a:ext>
              </a:extLst>
            </p:cNvPr>
            <p:cNvSpPr txBox="1"/>
            <p:nvPr/>
          </p:nvSpPr>
          <p:spPr>
            <a:xfrm>
              <a:off x="3909270" y="738231"/>
              <a:ext cx="4404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HFNC Success (n = 226)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5373AE28-D83A-4AAE-A5FB-3D3BE5F60268}"/>
              </a:ext>
            </a:extLst>
          </p:cNvPr>
          <p:cNvGrpSpPr/>
          <p:nvPr/>
        </p:nvGrpSpPr>
        <p:grpSpPr>
          <a:xfrm>
            <a:off x="6609391" y="6045722"/>
            <a:ext cx="5167618" cy="654341"/>
            <a:chOff x="3512191" y="629174"/>
            <a:chExt cx="5167618" cy="654341"/>
          </a:xfrm>
        </p:grpSpPr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DB585DC0-BB11-4A90-94DD-733F14CA0AEE}"/>
                </a:ext>
              </a:extLst>
            </p:cNvPr>
            <p:cNvSpPr/>
            <p:nvPr/>
          </p:nvSpPr>
          <p:spPr>
            <a:xfrm>
              <a:off x="3512191" y="629174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C1C17D8-6D98-403D-A1B1-B6C6778062A6}"/>
                </a:ext>
              </a:extLst>
            </p:cNvPr>
            <p:cNvSpPr txBox="1"/>
            <p:nvPr/>
          </p:nvSpPr>
          <p:spPr>
            <a:xfrm>
              <a:off x="3909270" y="738231"/>
              <a:ext cx="4404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HFNC Failure (n = 50)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8" name="그룹 17">
            <a:extLst>
              <a:ext uri="{FF2B5EF4-FFF2-40B4-BE49-F238E27FC236}">
                <a16:creationId xmlns:a16="http://schemas.microsoft.com/office/drawing/2014/main" id="{0398648A-9F09-4466-AF80-5A050E19B076}"/>
              </a:ext>
            </a:extLst>
          </p:cNvPr>
          <p:cNvGrpSpPr/>
          <p:nvPr/>
        </p:nvGrpSpPr>
        <p:grpSpPr>
          <a:xfrm>
            <a:off x="7237440" y="1119947"/>
            <a:ext cx="4555224" cy="920079"/>
            <a:chOff x="3512191" y="650958"/>
            <a:chExt cx="5167618" cy="671745"/>
          </a:xfrm>
        </p:grpSpPr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01705ED8-F2C7-4C6D-8906-7EA5B92207A2}"/>
                </a:ext>
              </a:extLst>
            </p:cNvPr>
            <p:cNvSpPr/>
            <p:nvPr/>
          </p:nvSpPr>
          <p:spPr>
            <a:xfrm>
              <a:off x="3512191" y="668362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CBFA605-ADF0-4DAD-B096-19D42A46F6A0}"/>
                </a:ext>
              </a:extLst>
            </p:cNvPr>
            <p:cNvSpPr txBox="1"/>
            <p:nvPr/>
          </p:nvSpPr>
          <p:spPr>
            <a:xfrm>
              <a:off x="3735836" y="650958"/>
              <a:ext cx="4926209" cy="6366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No extubation for ICU period (n = 222) </a:t>
              </a:r>
            </a:p>
            <a:p>
              <a:pPr>
                <a:lnSpc>
                  <a:spcPct val="150000"/>
                </a:lnSpc>
              </a:pP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Insufficient EMR (n = 52)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2" name="직선 연결선 21">
            <a:extLst>
              <a:ext uri="{FF2B5EF4-FFF2-40B4-BE49-F238E27FC236}">
                <a16:creationId xmlns:a16="http://schemas.microsoft.com/office/drawing/2014/main" id="{0AF0F770-2C4E-4BAD-BCD4-C6FC624528AC}"/>
              </a:ext>
            </a:extLst>
          </p:cNvPr>
          <p:cNvCxnSpPr>
            <a:cxnSpLocks/>
          </p:cNvCxnSpPr>
          <p:nvPr/>
        </p:nvCxnSpPr>
        <p:spPr>
          <a:xfrm>
            <a:off x="6088310" y="2928859"/>
            <a:ext cx="1" cy="132858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3623EAE3-2E77-4011-AEFF-A17E65E55680}"/>
              </a:ext>
            </a:extLst>
          </p:cNvPr>
          <p:cNvCxnSpPr>
            <a:cxnSpLocks/>
          </p:cNvCxnSpPr>
          <p:nvPr/>
        </p:nvCxnSpPr>
        <p:spPr>
          <a:xfrm>
            <a:off x="2886250" y="5556811"/>
            <a:ext cx="0" cy="48761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연결선 24">
            <a:extLst>
              <a:ext uri="{FF2B5EF4-FFF2-40B4-BE49-F238E27FC236}">
                <a16:creationId xmlns:a16="http://schemas.microsoft.com/office/drawing/2014/main" id="{7F55663F-46DF-4E2B-8783-C8A78BCF995B}"/>
              </a:ext>
            </a:extLst>
          </p:cNvPr>
          <p:cNvCxnSpPr>
            <a:cxnSpLocks/>
          </p:cNvCxnSpPr>
          <p:nvPr/>
        </p:nvCxnSpPr>
        <p:spPr>
          <a:xfrm>
            <a:off x="9181626" y="5545970"/>
            <a:ext cx="0" cy="487612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연결선 26">
            <a:extLst>
              <a:ext uri="{FF2B5EF4-FFF2-40B4-BE49-F238E27FC236}">
                <a16:creationId xmlns:a16="http://schemas.microsoft.com/office/drawing/2014/main" id="{46C6AF6D-D47F-4A66-A7C8-09A62BCDDEFD}"/>
              </a:ext>
            </a:extLst>
          </p:cNvPr>
          <p:cNvCxnSpPr>
            <a:cxnSpLocks/>
          </p:cNvCxnSpPr>
          <p:nvPr/>
        </p:nvCxnSpPr>
        <p:spPr>
          <a:xfrm>
            <a:off x="2872988" y="5543615"/>
            <a:ext cx="6325999" cy="8039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3ADE6B9A-416A-4B19-9B17-13DAC56B989D}"/>
              </a:ext>
            </a:extLst>
          </p:cNvPr>
          <p:cNvCxnSpPr>
            <a:cxnSpLocks/>
          </p:cNvCxnSpPr>
          <p:nvPr/>
        </p:nvCxnSpPr>
        <p:spPr>
          <a:xfrm>
            <a:off x="6111380" y="1582488"/>
            <a:ext cx="11353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F06F1AF1-4B22-4F92-AA18-1DF8665A7EC4}"/>
              </a:ext>
            </a:extLst>
          </p:cNvPr>
          <p:cNvCxnSpPr>
            <a:cxnSpLocks/>
          </p:cNvCxnSpPr>
          <p:nvPr/>
        </p:nvCxnSpPr>
        <p:spPr>
          <a:xfrm>
            <a:off x="6088310" y="4920171"/>
            <a:ext cx="0" cy="619474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4" name="그룹 23">
            <a:extLst>
              <a:ext uri="{FF2B5EF4-FFF2-40B4-BE49-F238E27FC236}">
                <a16:creationId xmlns:a16="http://schemas.microsoft.com/office/drawing/2014/main" id="{8DBB984D-F614-4F55-8724-DC0C35F8C1B3}"/>
              </a:ext>
            </a:extLst>
          </p:cNvPr>
          <p:cNvGrpSpPr/>
          <p:nvPr/>
        </p:nvGrpSpPr>
        <p:grpSpPr>
          <a:xfrm>
            <a:off x="1796917" y="2258775"/>
            <a:ext cx="8628925" cy="654341"/>
            <a:chOff x="3512191" y="629174"/>
            <a:chExt cx="5167618" cy="654341"/>
          </a:xfrm>
        </p:grpSpPr>
        <p:sp>
          <p:nvSpPr>
            <p:cNvPr id="26" name="직사각형 25">
              <a:extLst>
                <a:ext uri="{FF2B5EF4-FFF2-40B4-BE49-F238E27FC236}">
                  <a16:creationId xmlns:a16="http://schemas.microsoft.com/office/drawing/2014/main" id="{14F92BD7-E360-49AC-8F9D-FF3B58599E83}"/>
                </a:ext>
              </a:extLst>
            </p:cNvPr>
            <p:cNvSpPr/>
            <p:nvPr/>
          </p:nvSpPr>
          <p:spPr>
            <a:xfrm>
              <a:off x="3512191" y="629174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E33008C4-9A66-4945-AF3A-8B67ECEBAA8A}"/>
                </a:ext>
              </a:extLst>
            </p:cNvPr>
            <p:cNvSpPr txBox="1"/>
            <p:nvPr/>
          </p:nvSpPr>
          <p:spPr>
            <a:xfrm>
              <a:off x="3909270" y="738231"/>
              <a:ext cx="44042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606 patients passed the SBT and were</a:t>
              </a:r>
              <a:r>
                <a:rPr lang="ko-KR" alt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extubated</a:t>
              </a:r>
              <a:endParaRPr lang="ko-KR" altLang="en-US" sz="2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B36C35E7-7770-4812-8D15-C702CBD786A6}"/>
              </a:ext>
            </a:extLst>
          </p:cNvPr>
          <p:cNvGrpSpPr/>
          <p:nvPr/>
        </p:nvGrpSpPr>
        <p:grpSpPr>
          <a:xfrm>
            <a:off x="7246690" y="3148219"/>
            <a:ext cx="4555224" cy="920079"/>
            <a:chOff x="3512191" y="650958"/>
            <a:chExt cx="5167618" cy="671745"/>
          </a:xfrm>
        </p:grpSpPr>
        <p:sp>
          <p:nvSpPr>
            <p:cNvPr id="31" name="직사각형 30">
              <a:extLst>
                <a:ext uri="{FF2B5EF4-FFF2-40B4-BE49-F238E27FC236}">
                  <a16:creationId xmlns:a16="http://schemas.microsoft.com/office/drawing/2014/main" id="{FFF94DE4-3743-403E-BBD4-FD3148F9F41E}"/>
                </a:ext>
              </a:extLst>
            </p:cNvPr>
            <p:cNvSpPr/>
            <p:nvPr/>
          </p:nvSpPr>
          <p:spPr>
            <a:xfrm>
              <a:off x="3512191" y="668362"/>
              <a:ext cx="5167618" cy="654341"/>
            </a:xfrm>
            <a:prstGeom prst="rect">
              <a:avLst/>
            </a:prstGeom>
            <a:noFill/>
            <a:ln w="381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/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123FA41-268D-413A-883F-B2F32978C397}"/>
                </a:ext>
              </a:extLst>
            </p:cNvPr>
            <p:cNvSpPr txBox="1"/>
            <p:nvPr/>
          </p:nvSpPr>
          <p:spPr>
            <a:xfrm>
              <a:off x="3735837" y="650958"/>
              <a:ext cx="4720325" cy="6366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Low flow oxygen therapy (n = 288)</a:t>
              </a:r>
            </a:p>
            <a:p>
              <a:pPr>
                <a:lnSpc>
                  <a:spcPct val="150000"/>
                </a:lnSpc>
              </a:pP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Noninvasive ventilation (n = 42)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37" name="직선 연결선 36">
            <a:extLst>
              <a:ext uri="{FF2B5EF4-FFF2-40B4-BE49-F238E27FC236}">
                <a16:creationId xmlns:a16="http://schemas.microsoft.com/office/drawing/2014/main" id="{1590D2E4-47A8-4D15-BC9A-246ECF3CCD36}"/>
              </a:ext>
            </a:extLst>
          </p:cNvPr>
          <p:cNvCxnSpPr>
            <a:cxnSpLocks/>
          </p:cNvCxnSpPr>
          <p:nvPr/>
        </p:nvCxnSpPr>
        <p:spPr>
          <a:xfrm>
            <a:off x="6088310" y="938557"/>
            <a:ext cx="1" cy="1328587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8084CF85-8D61-40CC-B219-F09972864952}"/>
              </a:ext>
            </a:extLst>
          </p:cNvPr>
          <p:cNvCxnSpPr>
            <a:cxnSpLocks/>
          </p:cNvCxnSpPr>
          <p:nvPr/>
        </p:nvCxnSpPr>
        <p:spPr>
          <a:xfrm>
            <a:off x="6088310" y="3604731"/>
            <a:ext cx="1135310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505702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993347C-4599-49B6-A99D-66B4A5A8AFC2}"/>
              </a:ext>
            </a:extLst>
          </p:cNvPr>
          <p:cNvSpPr txBox="1"/>
          <p:nvPr/>
        </p:nvSpPr>
        <p:spPr>
          <a:xfrm>
            <a:off x="717116" y="0"/>
            <a:ext cx="285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a) ROX index at 2 hours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99C2A9-F9DA-444E-86DB-C92FD25BC080}"/>
              </a:ext>
            </a:extLst>
          </p:cNvPr>
          <p:cNvSpPr txBox="1"/>
          <p:nvPr/>
        </p:nvSpPr>
        <p:spPr>
          <a:xfrm>
            <a:off x="6642223" y="0"/>
            <a:ext cx="2853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b) ROX index at 6 hours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EB1F63-DAC4-42AF-BE71-01E9E6FBE56E}"/>
              </a:ext>
            </a:extLst>
          </p:cNvPr>
          <p:cNvSpPr txBox="1"/>
          <p:nvPr/>
        </p:nvSpPr>
        <p:spPr>
          <a:xfrm>
            <a:off x="720682" y="3509608"/>
            <a:ext cx="3156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c) ROX index at 12 hours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3B58ECBF-2523-4C1D-A2E9-2AD2AC4504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521" y="578289"/>
            <a:ext cx="3493132" cy="2541950"/>
          </a:xfrm>
          <a:prstGeom prst="rect">
            <a:avLst/>
          </a:prstGeom>
        </p:spPr>
      </p:pic>
      <p:grpSp>
        <p:nvGrpSpPr>
          <p:cNvPr id="2" name="그룹 1">
            <a:extLst>
              <a:ext uri="{FF2B5EF4-FFF2-40B4-BE49-F238E27FC236}">
                <a16:creationId xmlns:a16="http://schemas.microsoft.com/office/drawing/2014/main" id="{46677F36-36E2-4FB2-A70E-29E6C03A57EC}"/>
              </a:ext>
            </a:extLst>
          </p:cNvPr>
          <p:cNvGrpSpPr/>
          <p:nvPr/>
        </p:nvGrpSpPr>
        <p:grpSpPr>
          <a:xfrm>
            <a:off x="1200973" y="670622"/>
            <a:ext cx="4346043" cy="2710113"/>
            <a:chOff x="1154140" y="503308"/>
            <a:chExt cx="4346043" cy="2710113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0690B74-6BDB-4801-A3A7-D981532E1938}"/>
                </a:ext>
              </a:extLst>
            </p:cNvPr>
            <p:cNvSpPr txBox="1"/>
            <p:nvPr/>
          </p:nvSpPr>
          <p:spPr>
            <a:xfrm>
              <a:off x="2437708" y="2951811"/>
              <a:ext cx="22063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rom </a:t>
              </a:r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tubation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days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838EC6E-A73C-4184-BE9B-48B92DA5DF8B}"/>
                </a:ext>
              </a:extLst>
            </p:cNvPr>
            <p:cNvSpPr txBox="1"/>
            <p:nvPr/>
          </p:nvSpPr>
          <p:spPr>
            <a:xfrm>
              <a:off x="3450029" y="503308"/>
              <a:ext cx="1000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&gt; 8.7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A69EF3B-330E-482E-86AE-7F0492BAC9A9}"/>
                </a:ext>
              </a:extLst>
            </p:cNvPr>
            <p:cNvSpPr txBox="1"/>
            <p:nvPr/>
          </p:nvSpPr>
          <p:spPr>
            <a:xfrm>
              <a:off x="3450029" y="930008"/>
              <a:ext cx="1000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≤ 8.7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C9C493C-18AD-45CC-9016-7D4C451C944B}"/>
                </a:ext>
              </a:extLst>
            </p:cNvPr>
            <p:cNvSpPr txBox="1"/>
            <p:nvPr/>
          </p:nvSpPr>
          <p:spPr>
            <a:xfrm>
              <a:off x="4499663" y="512423"/>
              <a:ext cx="10005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73EB53E-F999-479D-A11F-ABE31FA7DFBF}"/>
                </a:ext>
              </a:extLst>
            </p:cNvPr>
            <p:cNvSpPr txBox="1"/>
            <p:nvPr/>
          </p:nvSpPr>
          <p:spPr>
            <a:xfrm rot="10800000">
              <a:off x="1154140" y="503308"/>
              <a:ext cx="523220" cy="21518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umulative probability- free of reintubation (%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그룹 3">
            <a:extLst>
              <a:ext uri="{FF2B5EF4-FFF2-40B4-BE49-F238E27FC236}">
                <a16:creationId xmlns:a16="http://schemas.microsoft.com/office/drawing/2014/main" id="{A099E5F8-C3AE-4F10-AA6B-46444AE480D3}"/>
              </a:ext>
            </a:extLst>
          </p:cNvPr>
          <p:cNvGrpSpPr/>
          <p:nvPr/>
        </p:nvGrpSpPr>
        <p:grpSpPr>
          <a:xfrm>
            <a:off x="1203253" y="3929998"/>
            <a:ext cx="4343762" cy="2928002"/>
            <a:chOff x="1154140" y="3750829"/>
            <a:chExt cx="4343762" cy="2928002"/>
          </a:xfrm>
        </p:grpSpPr>
        <p:pic>
          <p:nvPicPr>
            <p:cNvPr id="24" name="그림 23">
              <a:extLst>
                <a:ext uri="{FF2B5EF4-FFF2-40B4-BE49-F238E27FC236}">
                  <a16:creationId xmlns:a16="http://schemas.microsoft.com/office/drawing/2014/main" id="{32B19724-5511-40FD-9C72-494AD9C49E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11688" y="3750829"/>
              <a:ext cx="3493132" cy="2695835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5369A24-4A77-4841-B0BF-82A6D6886EBD}"/>
                </a:ext>
              </a:extLst>
            </p:cNvPr>
            <p:cNvSpPr txBox="1"/>
            <p:nvPr/>
          </p:nvSpPr>
          <p:spPr>
            <a:xfrm>
              <a:off x="2439106" y="6417221"/>
              <a:ext cx="22063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rom </a:t>
              </a:r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tubation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days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E85144E-5B17-47DF-B206-182F26EE5024}"/>
                </a:ext>
              </a:extLst>
            </p:cNvPr>
            <p:cNvSpPr txBox="1"/>
            <p:nvPr/>
          </p:nvSpPr>
          <p:spPr>
            <a:xfrm>
              <a:off x="3400914" y="3849939"/>
              <a:ext cx="1098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&gt; 10.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F00B4CF4-28D8-471E-B7AF-295F11CF74AD}"/>
                </a:ext>
              </a:extLst>
            </p:cNvPr>
            <p:cNvSpPr txBox="1"/>
            <p:nvPr/>
          </p:nvSpPr>
          <p:spPr>
            <a:xfrm>
              <a:off x="3400914" y="4122912"/>
              <a:ext cx="10473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≤ 10.4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50574AA-1472-4679-893E-AB33C348B1D3}"/>
                </a:ext>
              </a:extLst>
            </p:cNvPr>
            <p:cNvSpPr txBox="1"/>
            <p:nvPr/>
          </p:nvSpPr>
          <p:spPr>
            <a:xfrm>
              <a:off x="4450549" y="3856319"/>
              <a:ext cx="104735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= 0.004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FDF8275E-E2C9-42EE-9AC2-8DBE2A036689}"/>
                </a:ext>
              </a:extLst>
            </p:cNvPr>
            <p:cNvSpPr txBox="1"/>
            <p:nvPr/>
          </p:nvSpPr>
          <p:spPr>
            <a:xfrm rot="10800000">
              <a:off x="1154140" y="3856319"/>
              <a:ext cx="523220" cy="21518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umulative probability- free of reintubation (%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그룹 2">
            <a:extLst>
              <a:ext uri="{FF2B5EF4-FFF2-40B4-BE49-F238E27FC236}">
                <a16:creationId xmlns:a16="http://schemas.microsoft.com/office/drawing/2014/main" id="{AE48864F-AEC8-41DE-80CC-F92532A8E07B}"/>
              </a:ext>
            </a:extLst>
          </p:cNvPr>
          <p:cNvGrpSpPr/>
          <p:nvPr/>
        </p:nvGrpSpPr>
        <p:grpSpPr>
          <a:xfrm>
            <a:off x="7107621" y="578289"/>
            <a:ext cx="4387693" cy="2803561"/>
            <a:chOff x="7087182" y="409860"/>
            <a:chExt cx="4387693" cy="2803561"/>
          </a:xfrm>
        </p:grpSpPr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248E55B7-6C1C-49FE-820D-A078200C16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06043" y="409860"/>
              <a:ext cx="3592068" cy="2541951"/>
            </a:xfrm>
            <a:prstGeom prst="rect">
              <a:avLst/>
            </a:prstGeom>
          </p:spPr>
        </p:pic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53E04D4-0267-4B59-A6E8-F6583A90F9D4}"/>
                </a:ext>
              </a:extLst>
            </p:cNvPr>
            <p:cNvSpPr txBox="1"/>
            <p:nvPr/>
          </p:nvSpPr>
          <p:spPr>
            <a:xfrm>
              <a:off x="8391712" y="2951811"/>
              <a:ext cx="220630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ime</a:t>
              </a:r>
              <a:r>
                <a:rPr lang="ko-KR" alt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rom </a:t>
              </a:r>
              <a:r>
                <a:rPr lang="en-US" altLang="ko-KR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tubation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days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79CFF34-97CF-4C31-B457-E962F053A780}"/>
                </a:ext>
              </a:extLst>
            </p:cNvPr>
            <p:cNvSpPr txBox="1"/>
            <p:nvPr/>
          </p:nvSpPr>
          <p:spPr>
            <a:xfrm>
              <a:off x="9302077" y="503308"/>
              <a:ext cx="1000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&gt; 8.7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CCCFBE6-B0C6-41BB-B975-DEB70CDE46E9}"/>
                </a:ext>
              </a:extLst>
            </p:cNvPr>
            <p:cNvSpPr txBox="1"/>
            <p:nvPr/>
          </p:nvSpPr>
          <p:spPr>
            <a:xfrm>
              <a:off x="9302076" y="930008"/>
              <a:ext cx="10005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ROX ≤ 8.7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6D7777B-51AA-47C4-8DB1-9058AA83FCF4}"/>
                </a:ext>
              </a:extLst>
            </p:cNvPr>
            <p:cNvSpPr txBox="1"/>
            <p:nvPr/>
          </p:nvSpPr>
          <p:spPr>
            <a:xfrm>
              <a:off x="10515399" y="503308"/>
              <a:ext cx="959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 </a:t>
              </a:r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&lt; 0.001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AFCE311-95CB-47E1-BC4C-B39A009B826C}"/>
                </a:ext>
              </a:extLst>
            </p:cNvPr>
            <p:cNvSpPr txBox="1"/>
            <p:nvPr/>
          </p:nvSpPr>
          <p:spPr>
            <a:xfrm rot="10800000">
              <a:off x="7087182" y="503308"/>
              <a:ext cx="523220" cy="215189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umulative probability- free of reintubation (%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21981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2F0F23C6-F87C-4F17-9F73-20D4E6A7E2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562" y="0"/>
            <a:ext cx="6234896" cy="3507129"/>
          </a:xfrm>
          <a:prstGeom prst="rect">
            <a:avLst/>
          </a:prstGeom>
        </p:spPr>
      </p:pic>
      <p:pic>
        <p:nvPicPr>
          <p:cNvPr id="8" name="그림 7">
            <a:extLst>
              <a:ext uri="{FF2B5EF4-FFF2-40B4-BE49-F238E27FC236}">
                <a16:creationId xmlns:a16="http://schemas.microsoft.com/office/drawing/2014/main" id="{AE14E90C-53BC-4CA4-8897-898677A584D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41220" y="0"/>
            <a:ext cx="5592279" cy="3507129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6BB9BBB0-BE33-45AB-A160-F4F45F4F69D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44" y="3507129"/>
            <a:ext cx="6041494" cy="3350871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0B99E40-BE5F-44D4-BF54-3183A9F48D9F}"/>
              </a:ext>
            </a:extLst>
          </p:cNvPr>
          <p:cNvSpPr txBox="1"/>
          <p:nvPr/>
        </p:nvSpPr>
        <p:spPr>
          <a:xfrm>
            <a:off x="24879" y="-1058"/>
            <a:ext cx="3337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a) 2 hours  after </a:t>
            </a:r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xtubati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E49DED4-CF15-43A9-8598-A2D1FBB18D26}"/>
              </a:ext>
            </a:extLst>
          </p:cNvPr>
          <p:cNvSpPr txBox="1"/>
          <p:nvPr/>
        </p:nvSpPr>
        <p:spPr>
          <a:xfrm>
            <a:off x="6004886" y="-1058"/>
            <a:ext cx="3337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b) 6 hours  after </a:t>
            </a:r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xtubati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CAE021F-3CBB-46B7-88C8-476FCEFF9D11}"/>
              </a:ext>
            </a:extLst>
          </p:cNvPr>
          <p:cNvSpPr txBox="1"/>
          <p:nvPr/>
        </p:nvSpPr>
        <p:spPr>
          <a:xfrm>
            <a:off x="24879" y="3429000"/>
            <a:ext cx="33378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(c) 12 hours  after </a:t>
            </a:r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xtubati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87793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차트 8">
            <a:extLst>
              <a:ext uri="{FF2B5EF4-FFF2-40B4-BE49-F238E27FC236}">
                <a16:creationId xmlns:a16="http://schemas.microsoft.com/office/drawing/2014/main" id="{0F5D5ADF-DFA1-4110-8B67-A29DF8E56C6C}"/>
              </a:ext>
            </a:extLst>
          </p:cNvPr>
          <p:cNvGraphicFramePr>
            <a:graphicFrameLocks/>
          </p:cNvGraphicFramePr>
          <p:nvPr/>
        </p:nvGraphicFramePr>
        <p:xfrm>
          <a:off x="2225040" y="631013"/>
          <a:ext cx="7741920" cy="57111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E2C4B80A-A2ED-41C4-A6BF-CCD3CF44A46A}"/>
              </a:ext>
            </a:extLst>
          </p:cNvPr>
          <p:cNvSpPr txBox="1"/>
          <p:nvPr/>
        </p:nvSpPr>
        <p:spPr>
          <a:xfrm>
            <a:off x="1663065" y="3228945"/>
            <a:ext cx="561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6DA183A-809E-4BF4-911B-E254193D02E7}"/>
              </a:ext>
            </a:extLst>
          </p:cNvPr>
          <p:cNvSpPr txBox="1"/>
          <p:nvPr/>
        </p:nvSpPr>
        <p:spPr>
          <a:xfrm>
            <a:off x="4766178" y="6342204"/>
            <a:ext cx="28911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The number of factors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076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0F5D5ADF-DFA1-4110-8B67-A29DF8E56C6C}"/>
              </a:ext>
            </a:extLst>
          </p:cNvPr>
          <p:cNvGraphicFramePr>
            <a:graphicFrameLocks/>
          </p:cNvGraphicFramePr>
          <p:nvPr/>
        </p:nvGraphicFramePr>
        <p:xfrm>
          <a:off x="2225040" y="685993"/>
          <a:ext cx="7741920" cy="56706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FC52ED4-7CA6-4056-AEC9-0571A0610AF6}"/>
              </a:ext>
            </a:extLst>
          </p:cNvPr>
          <p:cNvSpPr txBox="1"/>
          <p:nvPr/>
        </p:nvSpPr>
        <p:spPr>
          <a:xfrm>
            <a:off x="1663065" y="3228945"/>
            <a:ext cx="561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128C24-0FE9-45A0-9794-B86B503CB9DC}"/>
              </a:ext>
            </a:extLst>
          </p:cNvPr>
          <p:cNvSpPr txBox="1"/>
          <p:nvPr/>
        </p:nvSpPr>
        <p:spPr>
          <a:xfrm>
            <a:off x="4869688" y="6356672"/>
            <a:ext cx="28795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The number of factors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95950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차트 3">
            <a:extLst>
              <a:ext uri="{FF2B5EF4-FFF2-40B4-BE49-F238E27FC236}">
                <a16:creationId xmlns:a16="http://schemas.microsoft.com/office/drawing/2014/main" id="{0F5D5ADF-DFA1-4110-8B67-A29DF8E56C6C}"/>
              </a:ext>
            </a:extLst>
          </p:cNvPr>
          <p:cNvGraphicFramePr>
            <a:graphicFrameLocks/>
          </p:cNvGraphicFramePr>
          <p:nvPr/>
        </p:nvGraphicFramePr>
        <p:xfrm>
          <a:off x="2225040" y="573405"/>
          <a:ext cx="7741920" cy="5711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62CED212-F7F3-4C83-A7B3-E048380C3573}"/>
              </a:ext>
            </a:extLst>
          </p:cNvPr>
          <p:cNvSpPr txBox="1"/>
          <p:nvPr/>
        </p:nvSpPr>
        <p:spPr>
          <a:xfrm>
            <a:off x="1663065" y="3228945"/>
            <a:ext cx="561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8EEA392-B89A-40A0-85CC-CF17DFDDB43A}"/>
              </a:ext>
            </a:extLst>
          </p:cNvPr>
          <p:cNvSpPr txBox="1"/>
          <p:nvPr/>
        </p:nvSpPr>
        <p:spPr>
          <a:xfrm>
            <a:off x="4898623" y="6284595"/>
            <a:ext cx="29316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The number of factors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2174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</TotalTime>
  <Words>186</Words>
  <Application>Microsoft Office PowerPoint</Application>
  <PresentationFormat>와이드스크린</PresentationFormat>
  <Paragraphs>36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9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영석</dc:creator>
  <cp:lastModifiedBy>이영석[ 교수 / 의학과 ]</cp:lastModifiedBy>
  <cp:revision>21</cp:revision>
  <dcterms:created xsi:type="dcterms:W3CDTF">2021-02-18T15:21:07Z</dcterms:created>
  <dcterms:modified xsi:type="dcterms:W3CDTF">2021-08-07T12:30:37Z</dcterms:modified>
</cp:coreProperties>
</file>